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8.xml.rels" ContentType="application/vnd.openxmlformats-package.relationships+xml"/>
  <Override PartName="/ppt/slides/_rels/slide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slide13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77B0EC-46F7-4E3D-BF82-79E28DA070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788E4-71C1-48EB-A82C-56A7E54017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7FF5DB-B054-4AFE-9DA4-B3135FD944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74DD74-BF30-4CA9-85A7-ADD75FCC1D8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76C88-3879-4C05-8DFE-D575368B27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02322-BB08-4F9B-81B9-C0023AA5F8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C214E1-C8E3-4FC8-8478-5E14DEEED0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06642-9359-493A-851B-B9C691977C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336693-AD4B-4258-AB5E-B4CA332C16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F77DE-E991-49A0-8F8D-008F93F79D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05B12-257F-4473-A73A-B1345F1891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CFB1D3-56E4-4C30-9713-F77E78FD5D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516DB6-4D92-4657-9068-2F4B65CD548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1: Adipose Chart 1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346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10: Liver Fold Change 2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igure S11: Skeletal Muscle Fold Change 1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igure S12: Skeletal Muscle Fold Change 2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Chart 3" descr=""/>
          <p:cNvPicPr/>
          <p:nvPr/>
        </p:nvPicPr>
        <p:blipFill>
          <a:blip r:embed="rId1"/>
          <a:stretch/>
        </p:blipFill>
        <p:spPr>
          <a:xfrm>
            <a:off x="237960" y="281160"/>
            <a:ext cx="8668080" cy="6295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Chart 3" descr=""/>
          <p:cNvPicPr/>
          <p:nvPr/>
        </p:nvPicPr>
        <p:blipFill>
          <a:blip r:embed="rId1"/>
          <a:stretch/>
        </p:blipFill>
        <p:spPr>
          <a:xfrm>
            <a:off x="237960" y="281160"/>
            <a:ext cx="8668080" cy="6295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716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gure S15: Robustness Analysi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8" name=""/>
          <p:cNvGraphicFramePr/>
          <p:nvPr/>
        </p:nvGraphicFramePr>
        <p:xfrm>
          <a:off x="609480" y="2514600"/>
          <a:ext cx="3048120" cy="2122560"/>
        </p:xfrm>
        <a:graphic>
          <a:graphicData uri="http://schemas.openxmlformats.org/drawingml/2006/table">
            <a:tbl>
              <a:tblPr/>
              <a:tblGrid>
                <a:gridCol w="1206720"/>
                <a:gridCol w="1001520"/>
                <a:gridCol w="839880"/>
              </a:tblGrid>
              <a:tr h="380880"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Mode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Metabolit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Reaction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47760"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Replicate 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28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455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49200"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Replicate 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282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454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47760"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Replicate 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289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469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49200"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Replicate 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28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45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347760"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Replicate 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27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68760" rIns="68760" tIns="0" bIns="0" anchor="b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spcAft>
                          <a:spcPts val="1001"/>
                        </a:spcAft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448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pic>
        <p:nvPicPr>
          <p:cNvPr id="69" name="Chart 2" descr=""/>
          <p:cNvPicPr/>
          <p:nvPr/>
        </p:nvPicPr>
        <p:blipFill>
          <a:blip r:embed="rId1"/>
          <a:stretch/>
        </p:blipFill>
        <p:spPr>
          <a:xfrm>
            <a:off x="3886200" y="1066680"/>
            <a:ext cx="4656240" cy="3573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2: Adipose Chart 2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3: Liver Chart 1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4: Liver Chart 2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5: Skeletal Muscle Chart 1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Content Placeholder 3" descr=""/>
          <p:cNvPicPr/>
          <p:nvPr/>
        </p:nvPicPr>
        <p:blipFill>
          <a:blip r:embed="rId1"/>
          <a:stretch/>
        </p:blipFill>
        <p:spPr>
          <a:xfrm>
            <a:off x="225360" y="1596960"/>
            <a:ext cx="869328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6: Skeletal Muscle Chart 2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7: Adipose Fold Change 1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8: Adipose Fold Change 2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Figure S9: Liver Fold Change 1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Content Placeholder 3" descr=""/>
          <p:cNvPicPr/>
          <p:nvPr/>
        </p:nvPicPr>
        <p:blipFill>
          <a:blip r:embed="rId1"/>
          <a:stretch/>
        </p:blipFill>
        <p:spPr>
          <a:xfrm>
            <a:off x="457200" y="1596960"/>
            <a:ext cx="8229600" cy="4529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7T20:03:01Z</dcterms:created>
  <dc:creator>Megamind</dc:creator>
  <dc:description/>
  <dc:language>en-US</dc:language>
  <cp:lastModifiedBy>Amit Kumar</cp:lastModifiedBy>
  <dcterms:modified xsi:type="dcterms:W3CDTF">2014-06-24T12:56:37Z</dcterms:modified>
  <cp:revision>714</cp:revision>
  <dc:subject/>
  <dc:title>Thesis Figures For Review</dc:title>
</cp:coreProperties>
</file>